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192000" cy="1332071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6" d="100"/>
          <a:sy n="36" d="100"/>
        </p:scale>
        <p:origin x="19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80034"/>
            <a:ext cx="10363200" cy="463758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996459"/>
            <a:ext cx="9144000" cy="3216088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2103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294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09204"/>
            <a:ext cx="2628900" cy="1128868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09204"/>
            <a:ext cx="7734300" cy="1128868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6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499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320931"/>
            <a:ext cx="10515600" cy="5541046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914398"/>
            <a:ext cx="10515600" cy="291390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744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546023"/>
            <a:ext cx="5181600" cy="845187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546023"/>
            <a:ext cx="5181600" cy="845187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01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09208"/>
            <a:ext cx="10515600" cy="257472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265426"/>
            <a:ext cx="5157787" cy="160033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865760"/>
            <a:ext cx="5157787" cy="715680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265426"/>
            <a:ext cx="5183188" cy="160033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865760"/>
            <a:ext cx="5183188" cy="715680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493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781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70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88048"/>
            <a:ext cx="3932237" cy="3108166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17939"/>
            <a:ext cx="6172200" cy="946634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996214"/>
            <a:ext cx="3932237" cy="74034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419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88048"/>
            <a:ext cx="3932237" cy="3108166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17939"/>
            <a:ext cx="6172200" cy="946634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996214"/>
            <a:ext cx="3932237" cy="740348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908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09208"/>
            <a:ext cx="10515600" cy="2574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546023"/>
            <a:ext cx="10515600" cy="84518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346330"/>
            <a:ext cx="27432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22619-1BA2-46D7-8E7C-6DFC3420346C}" type="datetimeFigureOut">
              <a:rPr lang="en-US" smtClean="0"/>
              <a:t>8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346330"/>
            <a:ext cx="41148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346330"/>
            <a:ext cx="2743200" cy="7092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8C4DB-1A1E-483E-A9E3-5557888148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856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image" Target="../media/image6.jpe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jpeg"/><Relationship Id="rId4" Type="http://schemas.openxmlformats.org/officeDocument/2006/relationships/image" Target="../media/image1.emf"/><Relationship Id="rId9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0416946"/>
              </p:ext>
            </p:extLst>
          </p:nvPr>
        </p:nvGraphicFramePr>
        <p:xfrm>
          <a:off x="7607747" y="236918"/>
          <a:ext cx="3769317" cy="2965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4" name="Prism 8" r:id="rId3" imgW="3489715" imgH="2536925" progId="Prism8.Document">
                  <p:embed/>
                </p:oleObj>
              </mc:Choice>
              <mc:Fallback>
                <p:oleObj name="Prism 8" r:id="rId3" imgW="3489715" imgH="253692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07747" y="236918"/>
                        <a:ext cx="3769317" cy="2965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5335482"/>
              </p:ext>
            </p:extLst>
          </p:nvPr>
        </p:nvGraphicFramePr>
        <p:xfrm>
          <a:off x="3921572" y="252795"/>
          <a:ext cx="3667125" cy="294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5" name="Prism 8" r:id="rId5" imgW="3462345" imgH="2735370" progId="Prism8.Document">
                  <p:embed/>
                </p:oleObj>
              </mc:Choice>
              <mc:Fallback>
                <p:oleObj name="Prism 8" r:id="rId5" imgW="3462345" imgH="273537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21572" y="252795"/>
                        <a:ext cx="3667125" cy="294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5138467"/>
              </p:ext>
            </p:extLst>
          </p:nvPr>
        </p:nvGraphicFramePr>
        <p:xfrm>
          <a:off x="433832" y="254380"/>
          <a:ext cx="3462338" cy="2947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8" r:id="rId7" imgW="3462345" imgH="2478940" progId="Prism8.Document">
                  <p:embed/>
                </p:oleObj>
              </mc:Choice>
              <mc:Fallback>
                <p:oleObj name="Prism 8" r:id="rId7" imgW="3462345" imgH="247894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3832" y="254380"/>
                        <a:ext cx="3462338" cy="2947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7150" y="80827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10456" y="52252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588695" y="-26125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27" b="8195"/>
          <a:stretch/>
        </p:blipFill>
        <p:spPr>
          <a:xfrm>
            <a:off x="473662" y="3202369"/>
            <a:ext cx="11390170" cy="322159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74" b="6985"/>
          <a:stretch/>
        </p:blipFill>
        <p:spPr>
          <a:xfrm>
            <a:off x="473662" y="6609929"/>
            <a:ext cx="11390170" cy="3108838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921572" y="3461351"/>
            <a:ext cx="6655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MSM01 across TCGA cancers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921572" y="6425260"/>
            <a:ext cx="6655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HMGCS1 across TCGA cancer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9980" y="3120594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7150" y="6327565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1678" y="9679218"/>
            <a:ext cx="80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74" b="7830"/>
          <a:stretch/>
        </p:blipFill>
        <p:spPr>
          <a:xfrm>
            <a:off x="473663" y="9939067"/>
            <a:ext cx="11390170" cy="320429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3921572" y="9718770"/>
            <a:ext cx="6655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MVD across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CGA cancers</a:t>
            </a:r>
          </a:p>
        </p:txBody>
      </p:sp>
    </p:spTree>
    <p:extLst>
      <p:ext uri="{BB962C8B-B14F-4D97-AF65-F5344CB8AC3E}">
        <p14:creationId xmlns:p14="http://schemas.microsoft.com/office/powerpoint/2010/main" val="4242032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7</TotalTime>
  <Words>36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14</cp:revision>
  <dcterms:created xsi:type="dcterms:W3CDTF">2022-06-23T08:05:18Z</dcterms:created>
  <dcterms:modified xsi:type="dcterms:W3CDTF">2022-08-25T13:59:33Z</dcterms:modified>
</cp:coreProperties>
</file>